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0F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ocuments\Dropbox\China_collaborators\Wenhui\Nitric_oxide\Shared%20folder\V2.7\Luminol%20data\Scintillator%20nonoat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uments\Dropbox\China_collaborators\Wenhui\Nitric_oxide\Shared%20folder\V2.7\Luminol%20data\Scintillator%20nonoat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NONOATE!$Q$5:$Q$7</c:f>
                <c:numCache>
                  <c:formatCode>General</c:formatCode>
                  <c:ptCount val="3"/>
                  <c:pt idx="0">
                    <c:v>132917.9206970887</c:v>
                  </c:pt>
                  <c:pt idx="1">
                    <c:v>10714.512972881412</c:v>
                  </c:pt>
                  <c:pt idx="2">
                    <c:v>11.778134166515683</c:v>
                  </c:pt>
                </c:numCache>
              </c:numRef>
            </c:plus>
            <c:minus>
              <c:numRef>
                <c:f>NONOATE!$Q$5:$Q$7</c:f>
                <c:numCache>
                  <c:formatCode>General</c:formatCode>
                  <c:ptCount val="3"/>
                  <c:pt idx="0">
                    <c:v>132917.9206970887</c:v>
                  </c:pt>
                  <c:pt idx="1">
                    <c:v>10714.512972881412</c:v>
                  </c:pt>
                  <c:pt idx="2">
                    <c:v>11.778134166515683</c:v>
                  </c:pt>
                </c:numCache>
              </c:numRef>
            </c:minus>
          </c:errBars>
          <c:cat>
            <c:strRef>
              <c:f>NONOATE!$N$5:$N$7</c:f>
              <c:strCache>
                <c:ptCount val="3"/>
                <c:pt idx="0">
                  <c:v>Test</c:v>
                </c:pt>
                <c:pt idx="1">
                  <c:v>Control</c:v>
                </c:pt>
                <c:pt idx="2">
                  <c:v>Blank</c:v>
                </c:pt>
              </c:strCache>
            </c:strRef>
          </c:cat>
          <c:val>
            <c:numRef>
              <c:f>NONOATE!$O$5:$O$7</c:f>
              <c:numCache>
                <c:formatCode>General</c:formatCode>
                <c:ptCount val="3"/>
                <c:pt idx="0">
                  <c:v>697867.66666666663</c:v>
                </c:pt>
                <c:pt idx="1">
                  <c:v>67303.666666666672</c:v>
                </c:pt>
                <c:pt idx="2">
                  <c:v>67.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38-4F81-82A8-451D687D2A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1110656"/>
        <c:axId val="391112192"/>
      </c:barChart>
      <c:catAx>
        <c:axId val="3911106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91112192"/>
        <c:crosses val="autoZero"/>
        <c:auto val="1"/>
        <c:lblAlgn val="ctr"/>
        <c:lblOffset val="100"/>
        <c:noMultiLvlLbl val="0"/>
      </c:catAx>
      <c:valAx>
        <c:axId val="39111219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PM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3911106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lg1'!$N$32</c:f>
              <c:strCache>
                <c:ptCount val="1"/>
                <c:pt idx="0">
                  <c:v>CPMA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lg1'!$P$33:$P$35</c:f>
                <c:numCache>
                  <c:formatCode>General</c:formatCode>
                  <c:ptCount val="3"/>
                  <c:pt idx="0">
                    <c:v>3540.1506761153541</c:v>
                  </c:pt>
                  <c:pt idx="1">
                    <c:v>4869.435078217778</c:v>
                  </c:pt>
                  <c:pt idx="2">
                    <c:v>16.411546071118472</c:v>
                  </c:pt>
                </c:numCache>
              </c:numRef>
            </c:plus>
            <c:minus>
              <c:numRef>
                <c:f>'Flg1'!$P$33:$P$35</c:f>
                <c:numCache>
                  <c:formatCode>General</c:formatCode>
                  <c:ptCount val="3"/>
                  <c:pt idx="0">
                    <c:v>3540.1506761153541</c:v>
                  </c:pt>
                  <c:pt idx="1">
                    <c:v>4869.435078217778</c:v>
                  </c:pt>
                  <c:pt idx="2">
                    <c:v>16.4115460711184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lg1'!$M$33:$M$35</c:f>
              <c:strCache>
                <c:ptCount val="3"/>
                <c:pt idx="0">
                  <c:v>Test</c:v>
                </c:pt>
                <c:pt idx="1">
                  <c:v>Control</c:v>
                </c:pt>
                <c:pt idx="2">
                  <c:v>Blank</c:v>
                </c:pt>
              </c:strCache>
            </c:strRef>
          </c:cat>
          <c:val>
            <c:numRef>
              <c:f>'Flg1'!$N$33:$N$35</c:f>
              <c:numCache>
                <c:formatCode>General</c:formatCode>
                <c:ptCount val="3"/>
                <c:pt idx="0">
                  <c:v>79919</c:v>
                </c:pt>
                <c:pt idx="1">
                  <c:v>60640.666666666664</c:v>
                </c:pt>
                <c:pt idx="2">
                  <c:v>53.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D0-482B-BCC1-48C6383127B5}"/>
            </c:ext>
          </c:extLst>
        </c:ser>
        <c:ser>
          <c:idx val="1"/>
          <c:order val="1"/>
          <c:tx>
            <c:strRef>
              <c:f>'Flg1'!$N$36</c:f>
              <c:strCache>
                <c:ptCount val="1"/>
                <c:pt idx="0">
                  <c:v>CPMA15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lg1'!$P$37:$P$39</c:f>
                <c:numCache>
                  <c:formatCode>General</c:formatCode>
                  <c:ptCount val="3"/>
                  <c:pt idx="0">
                    <c:v>4643.8807868898248</c:v>
                  </c:pt>
                  <c:pt idx="1">
                    <c:v>6068.2826394440281</c:v>
                  </c:pt>
                  <c:pt idx="2">
                    <c:v>5.8800000000000008</c:v>
                  </c:pt>
                </c:numCache>
              </c:numRef>
            </c:plus>
            <c:minus>
              <c:numRef>
                <c:f>'Flg1'!$P$37:$P$39</c:f>
                <c:numCache>
                  <c:formatCode>General</c:formatCode>
                  <c:ptCount val="3"/>
                  <c:pt idx="0">
                    <c:v>4643.8807868898248</c:v>
                  </c:pt>
                  <c:pt idx="1">
                    <c:v>6068.2826394440281</c:v>
                  </c:pt>
                  <c:pt idx="2">
                    <c:v>5.88000000000000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lg1'!$N$37:$N$39</c:f>
              <c:numCache>
                <c:formatCode>General</c:formatCode>
                <c:ptCount val="3"/>
                <c:pt idx="0">
                  <c:v>121322.33333333333</c:v>
                </c:pt>
                <c:pt idx="1">
                  <c:v>66078.333333333328</c:v>
                </c:pt>
                <c:pt idx="2">
                  <c:v>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FD0-482B-BCC1-48C6383127B5}"/>
            </c:ext>
          </c:extLst>
        </c:ser>
        <c:ser>
          <c:idx val="2"/>
          <c:order val="2"/>
          <c:tx>
            <c:strRef>
              <c:f>'Flg1'!$N$40</c:f>
              <c:strCache>
                <c:ptCount val="1"/>
                <c:pt idx="0">
                  <c:v>CPMA3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lg1'!$P$41:$P$43</c:f>
                <c:numCache>
                  <c:formatCode>General</c:formatCode>
                  <c:ptCount val="3"/>
                  <c:pt idx="0">
                    <c:v>22173.843749238527</c:v>
                  </c:pt>
                  <c:pt idx="1">
                    <c:v>5981.2810107237428</c:v>
                  </c:pt>
                  <c:pt idx="2">
                    <c:v>10.912818151146844</c:v>
                  </c:pt>
                </c:numCache>
              </c:numRef>
            </c:plus>
            <c:minus>
              <c:numRef>
                <c:f>'Flg1'!$P$41:$P$43</c:f>
                <c:numCache>
                  <c:formatCode>General</c:formatCode>
                  <c:ptCount val="3"/>
                  <c:pt idx="0">
                    <c:v>22173.843749238527</c:v>
                  </c:pt>
                  <c:pt idx="1">
                    <c:v>5981.2810107237428</c:v>
                  </c:pt>
                  <c:pt idx="2">
                    <c:v>10.9128181511468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lg1'!$N$41:$N$43</c:f>
              <c:numCache>
                <c:formatCode>General</c:formatCode>
                <c:ptCount val="3"/>
                <c:pt idx="0">
                  <c:v>230380.33333333334</c:v>
                </c:pt>
                <c:pt idx="1">
                  <c:v>67314.666666666672</c:v>
                </c:pt>
                <c:pt idx="2">
                  <c:v>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FD0-482B-BCC1-48C6383127B5}"/>
            </c:ext>
          </c:extLst>
        </c:ser>
        <c:ser>
          <c:idx val="3"/>
          <c:order val="3"/>
          <c:tx>
            <c:strRef>
              <c:f>'Flg1'!$N$44</c:f>
              <c:strCache>
                <c:ptCount val="1"/>
                <c:pt idx="0">
                  <c:v>CPMA45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lg1'!$P$45:$P$47</c:f>
                <c:numCache>
                  <c:formatCode>General</c:formatCode>
                  <c:ptCount val="3"/>
                  <c:pt idx="0">
                    <c:v>54636.743690520612</c:v>
                  </c:pt>
                  <c:pt idx="1">
                    <c:v>8250.1748291563163</c:v>
                  </c:pt>
                  <c:pt idx="2">
                    <c:v>14.239069882232853</c:v>
                  </c:pt>
                </c:numCache>
              </c:numRef>
            </c:plus>
            <c:minus>
              <c:numRef>
                <c:f>'Flg1'!$P$45:$P$47</c:f>
                <c:numCache>
                  <c:formatCode>General</c:formatCode>
                  <c:ptCount val="3"/>
                  <c:pt idx="0">
                    <c:v>54636.743690520612</c:v>
                  </c:pt>
                  <c:pt idx="1">
                    <c:v>8250.1748291563163</c:v>
                  </c:pt>
                  <c:pt idx="2">
                    <c:v>14.2390698822328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lg1'!$N$45:$N$47</c:f>
              <c:numCache>
                <c:formatCode>General</c:formatCode>
                <c:ptCount val="3"/>
                <c:pt idx="0">
                  <c:v>393937.33333333331</c:v>
                </c:pt>
                <c:pt idx="1">
                  <c:v>66952.666666666672</c:v>
                </c:pt>
                <c:pt idx="2">
                  <c:v>60.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FD0-482B-BCC1-48C6383127B5}"/>
            </c:ext>
          </c:extLst>
        </c:ser>
        <c:ser>
          <c:idx val="4"/>
          <c:order val="4"/>
          <c:tx>
            <c:strRef>
              <c:f>'Flg1'!$N$48</c:f>
              <c:strCache>
                <c:ptCount val="1"/>
                <c:pt idx="0">
                  <c:v>CPMA60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lg1'!$P$49:$P$51</c:f>
                <c:numCache>
                  <c:formatCode>General</c:formatCode>
                  <c:ptCount val="3"/>
                  <c:pt idx="0">
                    <c:v>93467.763549556941</c:v>
                  </c:pt>
                  <c:pt idx="1">
                    <c:v>9361.3973464743704</c:v>
                  </c:pt>
                  <c:pt idx="2">
                    <c:v>6.3005184971820638</c:v>
                  </c:pt>
                </c:numCache>
              </c:numRef>
            </c:plus>
            <c:minus>
              <c:numRef>
                <c:f>'Flg1'!$P$49:$P$51</c:f>
                <c:numCache>
                  <c:formatCode>General</c:formatCode>
                  <c:ptCount val="3"/>
                  <c:pt idx="0">
                    <c:v>93467.763549556941</c:v>
                  </c:pt>
                  <c:pt idx="1">
                    <c:v>9361.3973464743704</c:v>
                  </c:pt>
                  <c:pt idx="2">
                    <c:v>6.30051849718206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lg1'!$N$49:$N$51</c:f>
              <c:numCache>
                <c:formatCode>General</c:formatCode>
                <c:ptCount val="3"/>
                <c:pt idx="0">
                  <c:v>570846.66666666663</c:v>
                </c:pt>
                <c:pt idx="1">
                  <c:v>67162.666666666672</c:v>
                </c:pt>
                <c:pt idx="2">
                  <c:v>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FD0-482B-BCC1-48C6383127B5}"/>
            </c:ext>
          </c:extLst>
        </c:ser>
        <c:ser>
          <c:idx val="5"/>
          <c:order val="5"/>
          <c:tx>
            <c:strRef>
              <c:f>'Flg1'!$N$52</c:f>
              <c:strCache>
                <c:ptCount val="1"/>
                <c:pt idx="0">
                  <c:v>CPMA75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lg1'!$P$53:$P$55</c:f>
                <c:numCache>
                  <c:formatCode>General</c:formatCode>
                  <c:ptCount val="3"/>
                  <c:pt idx="0">
                    <c:v>132917.9206970887</c:v>
                  </c:pt>
                  <c:pt idx="1">
                    <c:v>10714.512972881412</c:v>
                  </c:pt>
                  <c:pt idx="2">
                    <c:v>11.778134166515683</c:v>
                  </c:pt>
                </c:numCache>
              </c:numRef>
            </c:plus>
            <c:minus>
              <c:numRef>
                <c:f>'Flg1'!$P$53:$P$55</c:f>
                <c:numCache>
                  <c:formatCode>General</c:formatCode>
                  <c:ptCount val="3"/>
                  <c:pt idx="0">
                    <c:v>132917.9206970887</c:v>
                  </c:pt>
                  <c:pt idx="1">
                    <c:v>10714.512972881412</c:v>
                  </c:pt>
                  <c:pt idx="2">
                    <c:v>11.7781341665156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lg1'!$N$53:$N$55</c:f>
              <c:numCache>
                <c:formatCode>General</c:formatCode>
                <c:ptCount val="3"/>
                <c:pt idx="0">
                  <c:v>697867.66666666663</c:v>
                </c:pt>
                <c:pt idx="1">
                  <c:v>67303.666666666672</c:v>
                </c:pt>
                <c:pt idx="2">
                  <c:v>67.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FD0-482B-BCC1-48C6383127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6212024"/>
        <c:axId val="736215304"/>
      </c:barChart>
      <c:catAx>
        <c:axId val="736212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6215304"/>
        <c:crosses val="autoZero"/>
        <c:auto val="1"/>
        <c:lblAlgn val="ctr"/>
        <c:lblOffset val="100"/>
        <c:noMultiLvlLbl val="0"/>
      </c:catAx>
      <c:valAx>
        <c:axId val="7362153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P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6212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FD36B-F123-46EA-B6AE-6F261DBCCF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441748-C5B6-4D98-A2CB-9A94C353D1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D9C749-C3D4-45C7-97EC-FC8065A8A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4C9C0C-8FBF-406C-97F4-6E638E5FE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C35807-E5EA-479D-8D77-E00240C90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555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67DDC-828C-435C-9B6E-F7F703FBE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D87874-F80E-435A-B8E8-2D50CAE69D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F26120-4317-4013-8D03-844AB0C8E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453AD4-4F92-42A0-965B-3B1781A13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6B54A4-58D4-4E1A-9A2F-B4C8858E8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18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885CFD-B8DC-4A08-89C5-2D2EEF11D5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38B114-66CC-45B7-957E-5A571C5A73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68B38-0DC5-4DF4-B07A-020826DFB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61E4FC-93FE-4CDE-9642-19F6E1F83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ACF285-B60A-4B50-9A2C-6F7D358D5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243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C5C80-3CF1-451D-8C40-26CD7983E7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E3D80F-9A41-4FB4-A3E8-05E3B98B28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16D4CF-DDE6-4756-9791-444299952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C80AE-72D4-43BC-BE1C-044D11E19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894AEF-2FDE-4EC7-BCDF-45D1C1FED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53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B53A4-7ED4-4328-86FD-164635BE09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F8AC30-05E8-452A-AB2A-227B825514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E2625B-1B15-4985-89EB-470299570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37035-6A84-4A2A-8473-627229F3B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961E07-5C7E-47AD-8A6B-4E41A030E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337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720FCE-9C95-4905-B7FC-824270515C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29DCD9-F2D6-411C-AA63-0AEBDC6BA0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2392A4-3AC0-46CD-9137-8DDCA98507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9AFF4D-4F93-46CD-B47B-4271E2552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356A71-0AEA-4E69-9C13-B5CF91BC0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6DA660-31E4-4978-95D8-0349C19DA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725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EFB1B7-9DC2-4BA2-93C2-C93057C73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5EBD98-D72C-4E1E-A094-84E8CE896B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20C597-FAF5-4E99-BF5D-4477307DED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F32CC6-1605-4D78-8556-3943859696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489741-0912-4A70-B050-661D75FABD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CCF889-7223-4412-A0C5-15C5160B4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7D8AFE-98A9-4BDF-AA25-769EB480B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54DD01-D0A4-474D-A5CF-2B04440F7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447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C4699A-CCA9-4F1B-98FE-DA0B5540FD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806FC3-B7E8-43AF-965D-9E710D71A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4197A8-841C-421C-AD13-216062E45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FB4C417-C1C7-4D21-B7A1-A47FC6993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772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F4F1B6-E2D0-4C41-9F47-078F48740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8D8878-CBF0-4EAA-9D51-FC0B5573C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9D6487-B0A9-4EFA-9AF5-36AE27578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566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0069E-A1D7-4C96-BA22-AFA556270F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032930-03A5-4B75-B116-DB350BDDBC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78AAA4-61FB-44E6-B24E-C321EC8E05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539418-BD43-48B6-A654-490969F4B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7EC563-1711-48AC-82DA-C144DE19C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DEC293-CA54-4BAB-9700-05DE06DC0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17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E8776C-CE43-4A92-99A2-9DAA2CE105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271EEC-DD93-42F5-944C-EBBB62CCF3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544963-103F-4102-8CDD-C2B9E1DBCC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53B5DE-D2E1-4064-9A91-41F5D3D82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1D8996-36AB-4492-A172-30B60DF54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E72253-BC3A-4736-AAE9-7C5F017C3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575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D89403-36A4-435F-85EB-0F508B066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C4FE2A-926C-4843-8098-F9E6300744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0A584-9E9E-4C0A-B169-EDB038C5AF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7D603-C0D6-466E-9ECC-F9C8D4797E1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062A8-687D-431B-AAA7-2D5BF50701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8F57B8-3A30-492C-9BA1-4A2E9A4FCF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8CC59-A968-4D4B-A878-D40688D0E2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400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0D3E379D-70AA-4700-8C1F-B2BA71648357}"/>
              </a:ext>
            </a:extLst>
          </p:cNvPr>
          <p:cNvGrpSpPr/>
          <p:nvPr/>
        </p:nvGrpSpPr>
        <p:grpSpPr>
          <a:xfrm>
            <a:off x="6738070" y="3053546"/>
            <a:ext cx="3834115" cy="2527332"/>
            <a:chOff x="3376310" y="2706255"/>
            <a:chExt cx="3834115" cy="2527332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E9B7557A-D0C6-484C-8D63-6DE7553F979F}"/>
                </a:ext>
              </a:extLst>
            </p:cNvPr>
            <p:cNvGrpSpPr/>
            <p:nvPr/>
          </p:nvGrpSpPr>
          <p:grpSpPr>
            <a:xfrm>
              <a:off x="3376310" y="2706255"/>
              <a:ext cx="862316" cy="2309090"/>
              <a:chOff x="3376310" y="2706255"/>
              <a:chExt cx="862316" cy="2309090"/>
            </a:xfrm>
          </p:grpSpPr>
          <p:sp>
            <p:nvSpPr>
              <p:cNvPr id="4" name="Cylinder 3">
                <a:extLst>
                  <a:ext uri="{FF2B5EF4-FFF2-40B4-BE49-F238E27FC236}">
                    <a16:creationId xmlns:a16="http://schemas.microsoft.com/office/drawing/2014/main" id="{C74C183B-BBC0-436D-8F02-3AD25C646A1B}"/>
                  </a:ext>
                </a:extLst>
              </p:cNvPr>
              <p:cNvSpPr/>
              <p:nvPr/>
            </p:nvSpPr>
            <p:spPr>
              <a:xfrm>
                <a:off x="3376310" y="2706255"/>
                <a:ext cx="848882" cy="2309090"/>
              </a:xfrm>
              <a:prstGeom prst="can">
                <a:avLst/>
              </a:prstGeom>
              <a:gradFill flip="none" rotWithShape="1">
                <a:gsLst>
                  <a:gs pos="0">
                    <a:schemeClr val="bg2">
                      <a:shade val="30000"/>
                      <a:satMod val="115000"/>
                    </a:schemeClr>
                  </a:gs>
                  <a:gs pos="19000">
                    <a:schemeClr val="bg2">
                      <a:shade val="67500"/>
                      <a:satMod val="115000"/>
                    </a:schemeClr>
                  </a:gs>
                  <a:gs pos="46000">
                    <a:schemeClr val="bg2">
                      <a:shade val="100000"/>
                      <a:satMod val="115000"/>
                    </a:schemeClr>
                  </a:gs>
                </a:gsLst>
                <a:lin ang="135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Cylinder 5">
                <a:extLst>
                  <a:ext uri="{FF2B5EF4-FFF2-40B4-BE49-F238E27FC236}">
                    <a16:creationId xmlns:a16="http://schemas.microsoft.com/office/drawing/2014/main" id="{E4C8C4BF-79E3-4935-AD1B-E164D07C5BCD}"/>
                  </a:ext>
                </a:extLst>
              </p:cNvPr>
              <p:cNvSpPr/>
              <p:nvPr/>
            </p:nvSpPr>
            <p:spPr>
              <a:xfrm>
                <a:off x="3389743" y="2706255"/>
                <a:ext cx="848883" cy="722745"/>
              </a:xfrm>
              <a:prstGeom prst="can">
                <a:avLst/>
              </a:prstGeom>
              <a:gradFill flip="none" rotWithShape="1">
                <a:gsLst>
                  <a:gs pos="0">
                    <a:schemeClr val="bg2">
                      <a:shade val="30000"/>
                      <a:satMod val="115000"/>
                    </a:schemeClr>
                  </a:gs>
                  <a:gs pos="19000">
                    <a:schemeClr val="bg2">
                      <a:shade val="67500"/>
                      <a:satMod val="115000"/>
                    </a:schemeClr>
                  </a:gs>
                  <a:gs pos="46000">
                    <a:schemeClr val="bg2">
                      <a:shade val="100000"/>
                      <a:satMod val="115000"/>
                    </a:schemeClr>
                  </a:gs>
                </a:gsLst>
                <a:lin ang="10800000" scaled="1"/>
                <a:tileRect/>
              </a:gradFill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AD4F7524-1CAB-42FE-958A-F1421E29829E}"/>
                  </a:ext>
                </a:extLst>
              </p:cNvPr>
              <p:cNvGrpSpPr/>
              <p:nvPr/>
            </p:nvGrpSpPr>
            <p:grpSpPr>
              <a:xfrm>
                <a:off x="3493336" y="3860800"/>
                <a:ext cx="641695" cy="1134986"/>
                <a:chOff x="3473106" y="3860800"/>
                <a:chExt cx="641695" cy="1134986"/>
              </a:xfrm>
              <a:solidFill>
                <a:schemeClr val="tx2">
                  <a:lumMod val="20000"/>
                  <a:lumOff val="80000"/>
                </a:schemeClr>
              </a:solidFill>
            </p:grpSpPr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38DCCD71-E21D-409E-8456-2CAD4D44B378}"/>
                    </a:ext>
                  </a:extLst>
                </p:cNvPr>
                <p:cNvGrpSpPr/>
                <p:nvPr/>
              </p:nvGrpSpPr>
              <p:grpSpPr>
                <a:xfrm>
                  <a:off x="3473106" y="3860800"/>
                  <a:ext cx="605955" cy="1134986"/>
                  <a:chOff x="3452719" y="3822427"/>
                  <a:chExt cx="605955" cy="1134986"/>
                </a:xfrm>
                <a:grpFill/>
              </p:grpSpPr>
              <p:sp>
                <p:nvSpPr>
                  <p:cNvPr id="8" name="Cylinder 7">
                    <a:extLst>
                      <a:ext uri="{FF2B5EF4-FFF2-40B4-BE49-F238E27FC236}">
                        <a16:creationId xmlns:a16="http://schemas.microsoft.com/office/drawing/2014/main" id="{85FE94CA-55C3-46EE-97C7-3E13922219EB}"/>
                      </a:ext>
                    </a:extLst>
                  </p:cNvPr>
                  <p:cNvSpPr/>
                  <p:nvPr/>
                </p:nvSpPr>
                <p:spPr>
                  <a:xfrm rot="1248830">
                    <a:off x="3653844" y="3822427"/>
                    <a:ext cx="404830" cy="782987"/>
                  </a:xfrm>
                  <a:prstGeom prst="can">
                    <a:avLst/>
                  </a:prstGeom>
                  <a:grp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" name="Trapezoid 10">
                    <a:extLst>
                      <a:ext uri="{FF2B5EF4-FFF2-40B4-BE49-F238E27FC236}">
                        <a16:creationId xmlns:a16="http://schemas.microsoft.com/office/drawing/2014/main" id="{0C2A9E26-4D77-44A4-A756-77BD11D7ADDC}"/>
                      </a:ext>
                    </a:extLst>
                  </p:cNvPr>
                  <p:cNvSpPr/>
                  <p:nvPr/>
                </p:nvSpPr>
                <p:spPr>
                  <a:xfrm rot="12048830">
                    <a:off x="3452719" y="4528585"/>
                    <a:ext cx="404830" cy="428828"/>
                  </a:xfrm>
                  <a:custGeom>
                    <a:avLst/>
                    <a:gdLst>
                      <a:gd name="connsiteX0" fmla="*/ 0 w 342900"/>
                      <a:gd name="connsiteY0" fmla="*/ 409575 h 409575"/>
                      <a:gd name="connsiteX1" fmla="*/ 85725 w 342900"/>
                      <a:gd name="connsiteY1" fmla="*/ 0 h 409575"/>
                      <a:gd name="connsiteX2" fmla="*/ 257175 w 342900"/>
                      <a:gd name="connsiteY2" fmla="*/ 0 h 409575"/>
                      <a:gd name="connsiteX3" fmla="*/ 342900 w 342900"/>
                      <a:gd name="connsiteY3" fmla="*/ 409575 h 409575"/>
                      <a:gd name="connsiteX4" fmla="*/ 0 w 342900"/>
                      <a:gd name="connsiteY4" fmla="*/ 409575 h 409575"/>
                      <a:gd name="connsiteX0" fmla="*/ 0 w 342900"/>
                      <a:gd name="connsiteY0" fmla="*/ 409575 h 409575"/>
                      <a:gd name="connsiteX1" fmla="*/ 95250 w 342900"/>
                      <a:gd name="connsiteY1" fmla="*/ 0 h 409575"/>
                      <a:gd name="connsiteX2" fmla="*/ 257175 w 342900"/>
                      <a:gd name="connsiteY2" fmla="*/ 0 h 409575"/>
                      <a:gd name="connsiteX3" fmla="*/ 342900 w 342900"/>
                      <a:gd name="connsiteY3" fmla="*/ 409575 h 409575"/>
                      <a:gd name="connsiteX4" fmla="*/ 0 w 342900"/>
                      <a:gd name="connsiteY4" fmla="*/ 409575 h 40957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342900" h="409575">
                        <a:moveTo>
                          <a:pt x="0" y="409575"/>
                        </a:moveTo>
                        <a:lnTo>
                          <a:pt x="95250" y="0"/>
                        </a:lnTo>
                        <a:lnTo>
                          <a:pt x="257175" y="0"/>
                        </a:lnTo>
                        <a:lnTo>
                          <a:pt x="342900" y="409575"/>
                        </a:lnTo>
                        <a:lnTo>
                          <a:pt x="0" y="409575"/>
                        </a:lnTo>
                        <a:close/>
                      </a:path>
                    </a:pathLst>
                  </a:custGeom>
                  <a:grp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6" name="Oval 15">
                  <a:extLst>
                    <a:ext uri="{FF2B5EF4-FFF2-40B4-BE49-F238E27FC236}">
                      <a16:creationId xmlns:a16="http://schemas.microsoft.com/office/drawing/2014/main" id="{3FF19842-5D2C-4A4B-83C1-9DBC8BD5A0FB}"/>
                    </a:ext>
                  </a:extLst>
                </p:cNvPr>
                <p:cNvSpPr/>
                <p:nvPr/>
              </p:nvSpPr>
              <p:spPr>
                <a:xfrm>
                  <a:off x="3712533" y="4104576"/>
                  <a:ext cx="402268" cy="66652"/>
                </a:xfrm>
                <a:prstGeom prst="ellipse">
                  <a:avLst/>
                </a:prstGeom>
                <a:grp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22" name="Arc 21">
                <a:extLst>
                  <a:ext uri="{FF2B5EF4-FFF2-40B4-BE49-F238E27FC236}">
                    <a16:creationId xmlns:a16="http://schemas.microsoft.com/office/drawing/2014/main" id="{D30F2812-B8D8-438B-9AB3-B85B7D3EAFBB}"/>
                  </a:ext>
                </a:extLst>
              </p:cNvPr>
              <p:cNvSpPr/>
              <p:nvPr/>
            </p:nvSpPr>
            <p:spPr>
              <a:xfrm>
                <a:off x="3376310" y="4678014"/>
                <a:ext cx="835697" cy="187816"/>
              </a:xfrm>
              <a:prstGeom prst="arc">
                <a:avLst>
                  <a:gd name="adj1" fmla="val 19858375"/>
                  <a:gd name="adj2" fmla="val 11918637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0FDDB99-BE22-4C2B-98CE-CBC14D434FFA}"/>
                </a:ext>
              </a:extLst>
            </p:cNvPr>
            <p:cNvSpPr txBox="1"/>
            <p:nvPr/>
          </p:nvSpPr>
          <p:spPr>
            <a:xfrm>
              <a:off x="4962525" y="4587256"/>
              <a:ext cx="22479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Fungus in water + </a:t>
              </a:r>
            </a:p>
            <a:p>
              <a:r>
                <a:rPr lang="en-US" dirty="0" err="1"/>
                <a:t>Flg</a:t>
              </a:r>
              <a:r>
                <a:rPr lang="en-US" dirty="0"/>
                <a:t>, </a:t>
              </a:r>
              <a:r>
                <a:rPr lang="en-US" dirty="0" err="1"/>
                <a:t>Suc</a:t>
              </a:r>
              <a:r>
                <a:rPr lang="en-US" dirty="0"/>
                <a:t> or water 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0F3DCCF-ED80-455C-8C34-1570C0261A00}"/>
                </a:ext>
              </a:extLst>
            </p:cNvPr>
            <p:cNvSpPr txBox="1"/>
            <p:nvPr/>
          </p:nvSpPr>
          <p:spPr>
            <a:xfrm>
              <a:off x="4962525" y="3986562"/>
              <a:ext cx="17427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uminol + H2O2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D2BE742C-EE0C-488B-BF9A-FA80A8ADA195}"/>
                </a:ext>
              </a:extLst>
            </p:cNvPr>
            <p:cNvCxnSpPr>
              <a:stCxn id="25" idx="1"/>
            </p:cNvCxnSpPr>
            <p:nvPr/>
          </p:nvCxnSpPr>
          <p:spPr>
            <a:xfrm flipH="1">
              <a:off x="3961145" y="4171228"/>
              <a:ext cx="1001380" cy="18466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B4FEF6DA-8BC8-490D-9595-23811B0DC977}"/>
                </a:ext>
              </a:extLst>
            </p:cNvPr>
            <p:cNvCxnSpPr>
              <a:cxnSpLocks/>
              <a:stCxn id="24" idx="1"/>
            </p:cNvCxnSpPr>
            <p:nvPr/>
          </p:nvCxnSpPr>
          <p:spPr>
            <a:xfrm flipH="1">
              <a:off x="3897123" y="4910422"/>
              <a:ext cx="1065402" cy="507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26DDDF6C-9115-40F5-9D74-71B6F52A5695}"/>
              </a:ext>
            </a:extLst>
          </p:cNvPr>
          <p:cNvGrpSpPr/>
          <p:nvPr/>
        </p:nvGrpSpPr>
        <p:grpSpPr>
          <a:xfrm>
            <a:off x="935845" y="3053546"/>
            <a:ext cx="4263582" cy="2527332"/>
            <a:chOff x="3376310" y="2706255"/>
            <a:chExt cx="4263582" cy="2527332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D82FD935-2420-41C2-A12F-9BB6688A2C1C}"/>
                </a:ext>
              </a:extLst>
            </p:cNvPr>
            <p:cNvGrpSpPr/>
            <p:nvPr/>
          </p:nvGrpSpPr>
          <p:grpSpPr>
            <a:xfrm>
              <a:off x="3376310" y="2706255"/>
              <a:ext cx="862316" cy="2309090"/>
              <a:chOff x="3376310" y="2706255"/>
              <a:chExt cx="862316" cy="2309090"/>
            </a:xfrm>
          </p:grpSpPr>
          <p:sp>
            <p:nvSpPr>
              <p:cNvPr id="37" name="Cylinder 36">
                <a:extLst>
                  <a:ext uri="{FF2B5EF4-FFF2-40B4-BE49-F238E27FC236}">
                    <a16:creationId xmlns:a16="http://schemas.microsoft.com/office/drawing/2014/main" id="{875F2BBE-D56D-4B85-B2EC-6A81C5ED501F}"/>
                  </a:ext>
                </a:extLst>
              </p:cNvPr>
              <p:cNvSpPr/>
              <p:nvPr/>
            </p:nvSpPr>
            <p:spPr>
              <a:xfrm>
                <a:off x="3376310" y="2706255"/>
                <a:ext cx="848882" cy="2309090"/>
              </a:xfrm>
              <a:prstGeom prst="can">
                <a:avLst/>
              </a:prstGeom>
              <a:gradFill flip="none" rotWithShape="1">
                <a:gsLst>
                  <a:gs pos="0">
                    <a:schemeClr val="bg2">
                      <a:shade val="30000"/>
                      <a:satMod val="115000"/>
                    </a:schemeClr>
                  </a:gs>
                  <a:gs pos="19000">
                    <a:schemeClr val="bg2">
                      <a:shade val="67500"/>
                      <a:satMod val="115000"/>
                    </a:schemeClr>
                  </a:gs>
                  <a:gs pos="46000">
                    <a:schemeClr val="bg2">
                      <a:shade val="100000"/>
                      <a:satMod val="115000"/>
                    </a:schemeClr>
                  </a:gs>
                </a:gsLst>
                <a:lin ang="135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Cylinder 37">
                <a:extLst>
                  <a:ext uri="{FF2B5EF4-FFF2-40B4-BE49-F238E27FC236}">
                    <a16:creationId xmlns:a16="http://schemas.microsoft.com/office/drawing/2014/main" id="{B3CEDD74-AAD0-462B-99C4-050036A42846}"/>
                  </a:ext>
                </a:extLst>
              </p:cNvPr>
              <p:cNvSpPr/>
              <p:nvPr/>
            </p:nvSpPr>
            <p:spPr>
              <a:xfrm>
                <a:off x="3389743" y="2706255"/>
                <a:ext cx="848883" cy="722745"/>
              </a:xfrm>
              <a:prstGeom prst="can">
                <a:avLst/>
              </a:prstGeom>
              <a:gradFill flip="none" rotWithShape="1">
                <a:gsLst>
                  <a:gs pos="0">
                    <a:schemeClr val="bg2">
                      <a:shade val="30000"/>
                      <a:satMod val="115000"/>
                    </a:schemeClr>
                  </a:gs>
                  <a:gs pos="19000">
                    <a:schemeClr val="bg2">
                      <a:shade val="67500"/>
                      <a:satMod val="115000"/>
                    </a:schemeClr>
                  </a:gs>
                  <a:gs pos="46000">
                    <a:schemeClr val="bg2">
                      <a:shade val="100000"/>
                      <a:satMod val="115000"/>
                    </a:schemeClr>
                  </a:gs>
                </a:gsLst>
                <a:lin ang="10800000" scaled="1"/>
                <a:tileRect/>
              </a:gradFill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36B13D93-C81F-42A6-A501-B0795B8313F2}"/>
                  </a:ext>
                </a:extLst>
              </p:cNvPr>
              <p:cNvGrpSpPr/>
              <p:nvPr/>
            </p:nvGrpSpPr>
            <p:grpSpPr>
              <a:xfrm>
                <a:off x="3493336" y="3860800"/>
                <a:ext cx="641695" cy="1134986"/>
                <a:chOff x="3473106" y="3860800"/>
                <a:chExt cx="641695" cy="1134986"/>
              </a:xfrm>
              <a:solidFill>
                <a:schemeClr val="tx2">
                  <a:lumMod val="20000"/>
                  <a:lumOff val="80000"/>
                </a:schemeClr>
              </a:solidFill>
            </p:grpSpPr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ADDB113D-E84E-4E50-BAFD-4176F6C986DE}"/>
                    </a:ext>
                  </a:extLst>
                </p:cNvPr>
                <p:cNvGrpSpPr/>
                <p:nvPr/>
              </p:nvGrpSpPr>
              <p:grpSpPr>
                <a:xfrm>
                  <a:off x="3473106" y="3860800"/>
                  <a:ext cx="605955" cy="1134986"/>
                  <a:chOff x="3452719" y="3822427"/>
                  <a:chExt cx="605955" cy="1134986"/>
                </a:xfrm>
                <a:grpFill/>
              </p:grpSpPr>
              <p:sp>
                <p:nvSpPr>
                  <p:cNvPr id="43" name="Cylinder 42">
                    <a:extLst>
                      <a:ext uri="{FF2B5EF4-FFF2-40B4-BE49-F238E27FC236}">
                        <a16:creationId xmlns:a16="http://schemas.microsoft.com/office/drawing/2014/main" id="{FE8E5626-9F39-4ABB-AF1A-184DFB489AF7}"/>
                      </a:ext>
                    </a:extLst>
                  </p:cNvPr>
                  <p:cNvSpPr/>
                  <p:nvPr/>
                </p:nvSpPr>
                <p:spPr>
                  <a:xfrm rot="1248830">
                    <a:off x="3653844" y="3822427"/>
                    <a:ext cx="404830" cy="782987"/>
                  </a:xfrm>
                  <a:prstGeom prst="can">
                    <a:avLst/>
                  </a:prstGeom>
                  <a:grp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4" name="Trapezoid 10">
                    <a:extLst>
                      <a:ext uri="{FF2B5EF4-FFF2-40B4-BE49-F238E27FC236}">
                        <a16:creationId xmlns:a16="http://schemas.microsoft.com/office/drawing/2014/main" id="{585B9FC8-E2EC-4FC9-B3DD-44AFC713D1B8}"/>
                      </a:ext>
                    </a:extLst>
                  </p:cNvPr>
                  <p:cNvSpPr/>
                  <p:nvPr/>
                </p:nvSpPr>
                <p:spPr>
                  <a:xfrm rot="12048830">
                    <a:off x="3452719" y="4528585"/>
                    <a:ext cx="404830" cy="428828"/>
                  </a:xfrm>
                  <a:custGeom>
                    <a:avLst/>
                    <a:gdLst>
                      <a:gd name="connsiteX0" fmla="*/ 0 w 342900"/>
                      <a:gd name="connsiteY0" fmla="*/ 409575 h 409575"/>
                      <a:gd name="connsiteX1" fmla="*/ 85725 w 342900"/>
                      <a:gd name="connsiteY1" fmla="*/ 0 h 409575"/>
                      <a:gd name="connsiteX2" fmla="*/ 257175 w 342900"/>
                      <a:gd name="connsiteY2" fmla="*/ 0 h 409575"/>
                      <a:gd name="connsiteX3" fmla="*/ 342900 w 342900"/>
                      <a:gd name="connsiteY3" fmla="*/ 409575 h 409575"/>
                      <a:gd name="connsiteX4" fmla="*/ 0 w 342900"/>
                      <a:gd name="connsiteY4" fmla="*/ 409575 h 409575"/>
                      <a:gd name="connsiteX0" fmla="*/ 0 w 342900"/>
                      <a:gd name="connsiteY0" fmla="*/ 409575 h 409575"/>
                      <a:gd name="connsiteX1" fmla="*/ 95250 w 342900"/>
                      <a:gd name="connsiteY1" fmla="*/ 0 h 409575"/>
                      <a:gd name="connsiteX2" fmla="*/ 257175 w 342900"/>
                      <a:gd name="connsiteY2" fmla="*/ 0 h 409575"/>
                      <a:gd name="connsiteX3" fmla="*/ 342900 w 342900"/>
                      <a:gd name="connsiteY3" fmla="*/ 409575 h 409575"/>
                      <a:gd name="connsiteX4" fmla="*/ 0 w 342900"/>
                      <a:gd name="connsiteY4" fmla="*/ 409575 h 40957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342900" h="409575">
                        <a:moveTo>
                          <a:pt x="0" y="409575"/>
                        </a:moveTo>
                        <a:lnTo>
                          <a:pt x="95250" y="0"/>
                        </a:lnTo>
                        <a:lnTo>
                          <a:pt x="257175" y="0"/>
                        </a:lnTo>
                        <a:lnTo>
                          <a:pt x="342900" y="409575"/>
                        </a:lnTo>
                        <a:lnTo>
                          <a:pt x="0" y="409575"/>
                        </a:lnTo>
                        <a:close/>
                      </a:path>
                    </a:pathLst>
                  </a:custGeom>
                  <a:grp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42" name="Oval 41">
                  <a:extLst>
                    <a:ext uri="{FF2B5EF4-FFF2-40B4-BE49-F238E27FC236}">
                      <a16:creationId xmlns:a16="http://schemas.microsoft.com/office/drawing/2014/main" id="{548E8AF4-A8B9-4681-AC0A-866749DEB8B4}"/>
                    </a:ext>
                  </a:extLst>
                </p:cNvPr>
                <p:cNvSpPr/>
                <p:nvPr/>
              </p:nvSpPr>
              <p:spPr>
                <a:xfrm>
                  <a:off x="3712533" y="4104576"/>
                  <a:ext cx="402268" cy="66652"/>
                </a:xfrm>
                <a:prstGeom prst="ellipse">
                  <a:avLst/>
                </a:prstGeom>
                <a:grp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0" name="Arc 39">
                <a:extLst>
                  <a:ext uri="{FF2B5EF4-FFF2-40B4-BE49-F238E27FC236}">
                    <a16:creationId xmlns:a16="http://schemas.microsoft.com/office/drawing/2014/main" id="{C8161EF4-8583-4DE9-BAA1-C9D572181006}"/>
                  </a:ext>
                </a:extLst>
              </p:cNvPr>
              <p:cNvSpPr/>
              <p:nvPr/>
            </p:nvSpPr>
            <p:spPr>
              <a:xfrm>
                <a:off x="3376310" y="4678014"/>
                <a:ext cx="835697" cy="187816"/>
              </a:xfrm>
              <a:prstGeom prst="arc">
                <a:avLst>
                  <a:gd name="adj1" fmla="val 19858375"/>
                  <a:gd name="adj2" fmla="val 11918637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339ECF3-9F79-49C4-966B-F09D7B07A979}"/>
                </a:ext>
              </a:extLst>
            </p:cNvPr>
            <p:cNvSpPr txBox="1"/>
            <p:nvPr/>
          </p:nvSpPr>
          <p:spPr>
            <a:xfrm>
              <a:off x="4962525" y="4587256"/>
              <a:ext cx="22479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Nonoate</a:t>
              </a:r>
              <a:r>
                <a:rPr lang="en-US" dirty="0"/>
                <a:t> or </a:t>
              </a:r>
            </a:p>
            <a:p>
              <a:r>
                <a:rPr lang="en-US" dirty="0"/>
                <a:t>water control + buffer 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AF4F630-030E-4139-9AA9-606A18C92465}"/>
                </a:ext>
              </a:extLst>
            </p:cNvPr>
            <p:cNvSpPr txBox="1"/>
            <p:nvPr/>
          </p:nvSpPr>
          <p:spPr>
            <a:xfrm>
              <a:off x="4962525" y="3768647"/>
              <a:ext cx="267736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Luminol + H2O2 or </a:t>
              </a:r>
            </a:p>
            <a:p>
              <a:r>
                <a:rPr lang="en-US" dirty="0"/>
                <a:t>no H2O2  control 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A9ECBA2A-425F-466B-9914-7842F0F8B5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96876" y="4251127"/>
              <a:ext cx="1042018" cy="8908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17FFB99D-2CAB-4B89-8C8F-C872CD33D378}"/>
                </a:ext>
              </a:extLst>
            </p:cNvPr>
            <p:cNvCxnSpPr>
              <a:cxnSpLocks/>
              <a:stCxn id="33" idx="1"/>
            </p:cNvCxnSpPr>
            <p:nvPr/>
          </p:nvCxnSpPr>
          <p:spPr>
            <a:xfrm flipH="1">
              <a:off x="3897123" y="4910422"/>
              <a:ext cx="1065402" cy="507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A1656C83-F782-4934-A0BD-D585B8D1F378}"/>
              </a:ext>
            </a:extLst>
          </p:cNvPr>
          <p:cNvSpPr txBox="1"/>
          <p:nvPr/>
        </p:nvSpPr>
        <p:spPr>
          <a:xfrm>
            <a:off x="593187" y="2047875"/>
            <a:ext cx="23047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est that system work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8A0060C-52FA-45AD-9EF9-4941E281CCF6}"/>
              </a:ext>
            </a:extLst>
          </p:cNvPr>
          <p:cNvSpPr txBox="1"/>
          <p:nvPr/>
        </p:nvSpPr>
        <p:spPr>
          <a:xfrm>
            <a:off x="6738070" y="2047875"/>
            <a:ext cx="3880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est F. graminearum makes gaseous NO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4BBB732-9D72-4F20-AA9B-C7A081B07595}"/>
              </a:ext>
            </a:extLst>
          </p:cNvPr>
          <p:cNvSpPr txBox="1"/>
          <p:nvPr/>
        </p:nvSpPr>
        <p:spPr>
          <a:xfrm>
            <a:off x="785002" y="5615068"/>
            <a:ext cx="531767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US" dirty="0"/>
              <a:t>Inner tube: Luminol + H2O2. Vial: </a:t>
            </a:r>
            <a:r>
              <a:rPr lang="en-US" dirty="0" err="1"/>
              <a:t>Nonoate</a:t>
            </a:r>
            <a:r>
              <a:rPr lang="en-US" dirty="0"/>
              <a:t> + buffer</a:t>
            </a:r>
          </a:p>
          <a:p>
            <a:pPr marL="342900" indent="-342900">
              <a:buFontTx/>
              <a:buAutoNum type="arabicPeriod"/>
            </a:pPr>
            <a:r>
              <a:rPr lang="en-US" dirty="0"/>
              <a:t>Inner tube: Luminol + H2O2. Vial: Water +buffer</a:t>
            </a:r>
          </a:p>
          <a:p>
            <a:pPr marL="342900" indent="-342900">
              <a:buFontTx/>
              <a:buAutoNum type="arabicPeriod"/>
            </a:pPr>
            <a:r>
              <a:rPr lang="en-US" dirty="0"/>
              <a:t>Inner tube: Luminol. Vial: Water + buffer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2DC8B32-EC8A-48BA-BB82-F0AEC2D11F84}"/>
              </a:ext>
            </a:extLst>
          </p:cNvPr>
          <p:cNvSpPr txBox="1"/>
          <p:nvPr/>
        </p:nvSpPr>
        <p:spPr>
          <a:xfrm>
            <a:off x="6096000" y="5615068"/>
            <a:ext cx="580428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US" dirty="0"/>
              <a:t>Inner tube: Luminol + H2O2. Vial: Fungus + </a:t>
            </a:r>
            <a:r>
              <a:rPr lang="en-US" dirty="0" err="1"/>
              <a:t>Flg</a:t>
            </a:r>
            <a:r>
              <a:rPr lang="en-US" dirty="0"/>
              <a:t> + sucrose</a:t>
            </a:r>
          </a:p>
          <a:p>
            <a:pPr marL="342900" indent="-342900">
              <a:buFontTx/>
              <a:buAutoNum type="arabicPeriod"/>
            </a:pPr>
            <a:r>
              <a:rPr lang="en-US" dirty="0"/>
              <a:t>Inner tube: Luminol + H2O2. Vial: Fungus + sucrose</a:t>
            </a:r>
          </a:p>
          <a:p>
            <a:pPr marL="342900" indent="-342900">
              <a:buFontTx/>
              <a:buAutoNum type="arabicPeriod"/>
            </a:pPr>
            <a:r>
              <a:rPr lang="en-US" dirty="0"/>
              <a:t>Inner tube: Luminol. Vial: Fungu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E503496-BDA8-4E7E-AC9F-16BAD88D6BC7}"/>
              </a:ext>
            </a:extLst>
          </p:cNvPr>
          <p:cNvSpPr txBox="1"/>
          <p:nvPr/>
        </p:nvSpPr>
        <p:spPr>
          <a:xfrm>
            <a:off x="249662" y="203706"/>
            <a:ext cx="1092316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adspace test if fungus makes gaseous NO. Luminol + H2O2 reacts with NO and gives chemiluminescence. Superoxide anion is not volatile and H2O2 is used so this is a test that gaseous NO is formed by the fungus.</a:t>
            </a:r>
          </a:p>
          <a:p>
            <a:endParaRPr lang="en-US" dirty="0"/>
          </a:p>
          <a:p>
            <a:r>
              <a:rPr lang="en-US" dirty="0"/>
              <a:t>DPTA </a:t>
            </a:r>
            <a:r>
              <a:rPr lang="en-US" dirty="0" err="1"/>
              <a:t>Nonoate</a:t>
            </a:r>
            <a:r>
              <a:rPr lang="en-US" dirty="0"/>
              <a:t> is stable in alkaline carbonate solution and is kept in that. NO is given off as soon as a solution is acidified by adding a few ul of that to 2 ml of a phosphate buffer (pH6 0.15 mM). The half-life of the DPTA </a:t>
            </a:r>
            <a:r>
              <a:rPr lang="en-US" dirty="0" err="1"/>
              <a:t>NONOate</a:t>
            </a:r>
            <a:r>
              <a:rPr lang="en-US" dirty="0"/>
              <a:t> is approximately 3h at pH7 at 37C and 5h at 22-25C (in the scintillator it is close to 25-28C when running)</a:t>
            </a:r>
          </a:p>
        </p:txBody>
      </p:sp>
    </p:spTree>
    <p:extLst>
      <p:ext uri="{BB962C8B-B14F-4D97-AF65-F5344CB8AC3E}">
        <p14:creationId xmlns:p14="http://schemas.microsoft.com/office/powerpoint/2010/main" val="1080464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4663230"/>
              </p:ext>
            </p:extLst>
          </p:nvPr>
        </p:nvGraphicFramePr>
        <p:xfrm>
          <a:off x="581025" y="1748790"/>
          <a:ext cx="3969544" cy="35185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57701F2A-D9E8-401A-86BD-B3F1094171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9258271"/>
              </p:ext>
            </p:extLst>
          </p:nvPr>
        </p:nvGraphicFramePr>
        <p:xfrm>
          <a:off x="6000750" y="1748789"/>
          <a:ext cx="5467350" cy="3518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0F5E152-61C1-4E6F-ACED-D77D81AB39C4}"/>
              </a:ext>
            </a:extLst>
          </p:cNvPr>
          <p:cNvSpPr txBox="1"/>
          <p:nvPr/>
        </p:nvSpPr>
        <p:spPr>
          <a:xfrm>
            <a:off x="267064" y="5464492"/>
            <a:ext cx="489396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Test</a:t>
            </a:r>
            <a:r>
              <a:rPr lang="en-US" sz="1600" dirty="0"/>
              <a:t> Inner tube: Luminol + H2O2. Vial: </a:t>
            </a:r>
            <a:r>
              <a:rPr lang="en-US" sz="1600" b="1" dirty="0" err="1"/>
              <a:t>Nonoate</a:t>
            </a:r>
            <a:r>
              <a:rPr lang="en-US" sz="1600" dirty="0" err="1"/>
              <a:t>+buffer</a:t>
            </a:r>
            <a:endParaRPr lang="en-US" sz="1600" dirty="0"/>
          </a:p>
          <a:p>
            <a:r>
              <a:rPr lang="en-US" sz="1600" b="1" dirty="0"/>
              <a:t>Control</a:t>
            </a:r>
            <a:r>
              <a:rPr lang="en-US" sz="1600" dirty="0"/>
              <a:t> Inner tube: Luminol + H2O2. Vial: Water + buffer</a:t>
            </a:r>
          </a:p>
          <a:p>
            <a:r>
              <a:rPr lang="en-US" sz="1600" b="1" dirty="0"/>
              <a:t>Blank</a:t>
            </a:r>
            <a:r>
              <a:rPr lang="en-US" sz="1600" dirty="0"/>
              <a:t> Inner tube: Luminol. Vial: buffe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539DDDC-93B6-4F3C-9CBC-1752BF1E8517}"/>
              </a:ext>
            </a:extLst>
          </p:cNvPr>
          <p:cNvSpPr txBox="1"/>
          <p:nvPr/>
        </p:nvSpPr>
        <p:spPr>
          <a:xfrm>
            <a:off x="5994963" y="5424012"/>
            <a:ext cx="6096000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/>
              <a:t>Test </a:t>
            </a:r>
            <a:r>
              <a:rPr lang="en-US" sz="1600" dirty="0"/>
              <a:t>Inner tube: Luminol + H2O2. Vial: Fungus + </a:t>
            </a:r>
            <a:r>
              <a:rPr lang="en-US" sz="1600" b="1" dirty="0"/>
              <a:t>Flagellin</a:t>
            </a:r>
            <a:r>
              <a:rPr lang="en-US" sz="1600" dirty="0"/>
              <a:t> + sucrose. </a:t>
            </a:r>
          </a:p>
          <a:p>
            <a:r>
              <a:rPr lang="en-US" sz="1600" b="1" dirty="0"/>
              <a:t>Control</a:t>
            </a:r>
            <a:r>
              <a:rPr lang="en-US" sz="1600" dirty="0"/>
              <a:t> Inner tube: Luminol + H2O2. Vial: Fungus + sucrose</a:t>
            </a:r>
          </a:p>
          <a:p>
            <a:r>
              <a:rPr lang="en-US" sz="1600" b="1" dirty="0"/>
              <a:t>Blank</a:t>
            </a:r>
            <a:r>
              <a:rPr lang="en-US" sz="1600" dirty="0"/>
              <a:t> Inner tube: Luminol. Vial: Fungus</a:t>
            </a:r>
          </a:p>
          <a:p>
            <a:r>
              <a:rPr lang="en-US" sz="1600" dirty="0"/>
              <a:t>Recordings done every 15 minutes for 75 minutes 0= about 2-3 min after treatment of the fungus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201B61D-70C7-4E6E-8BAA-D0B96D5FF5B0}"/>
              </a:ext>
            </a:extLst>
          </p:cNvPr>
          <p:cNvSpPr txBox="1"/>
          <p:nvPr/>
        </p:nvSpPr>
        <p:spPr>
          <a:xfrm>
            <a:off x="1103143" y="90070"/>
            <a:ext cx="949818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NO detection using a NO-donor (DPTA NONOATE) or from mycelium exposed to </a:t>
            </a:r>
            <a:r>
              <a:rPr lang="en-US" sz="1600" i="1" dirty="0"/>
              <a:t>Salmonella typhimurium</a:t>
            </a:r>
            <a:r>
              <a:rPr lang="en-US" sz="1600" dirty="0"/>
              <a:t> flagellin (that had been freeze dried in sucrose). Control: Sucrose with the same concentration as the test is used as control. The Blank is there to test there is no signal from the instrument and luminol itself. </a:t>
            </a:r>
          </a:p>
          <a:p>
            <a:r>
              <a:rPr lang="en-US" sz="1600" b="1" dirty="0"/>
              <a:t>Purpose of experiment: Test that NO is made by the fungus with an independent technique from DAF-FM DA and that gaseous NO is form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B2AFEB-BF7F-486D-BE51-2CBC7D989EED}"/>
              </a:ext>
            </a:extLst>
          </p:cNvPr>
          <p:cNvSpPr txBox="1"/>
          <p:nvPr/>
        </p:nvSpPr>
        <p:spPr>
          <a:xfrm>
            <a:off x="1336906" y="1345883"/>
            <a:ext cx="3964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PTA NONOATE to see used as </a:t>
            </a:r>
            <a:r>
              <a:rPr lang="en-US" dirty="0" err="1"/>
              <a:t>NOdonor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566CA5-4AF7-4A53-8C0C-46CDC4BE0C26}"/>
              </a:ext>
            </a:extLst>
          </p:cNvPr>
          <p:cNvSpPr txBox="1"/>
          <p:nvPr/>
        </p:nvSpPr>
        <p:spPr>
          <a:xfrm>
            <a:off x="5994963" y="1334929"/>
            <a:ext cx="956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agellin</a:t>
            </a:r>
          </a:p>
        </p:txBody>
      </p:sp>
    </p:spTree>
    <p:extLst>
      <p:ext uri="{BB962C8B-B14F-4D97-AF65-F5344CB8AC3E}">
        <p14:creationId xmlns:p14="http://schemas.microsoft.com/office/powerpoint/2010/main" val="6365598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4D23BD6-E04E-32C7-F65C-E2492745DA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1854738"/>
              </p:ext>
            </p:extLst>
          </p:nvPr>
        </p:nvGraphicFramePr>
        <p:xfrm>
          <a:off x="373224" y="242595"/>
          <a:ext cx="9815809" cy="635725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28967">
                  <a:extLst>
                    <a:ext uri="{9D8B030D-6E8A-4147-A177-3AD203B41FA5}">
                      <a16:colId xmlns:a16="http://schemas.microsoft.com/office/drawing/2014/main" val="952855137"/>
                    </a:ext>
                  </a:extLst>
                </a:gridCol>
                <a:gridCol w="933687">
                  <a:extLst>
                    <a:ext uri="{9D8B030D-6E8A-4147-A177-3AD203B41FA5}">
                      <a16:colId xmlns:a16="http://schemas.microsoft.com/office/drawing/2014/main" val="2548416195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499749822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3654499052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3750740029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3421530748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961348754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2930320492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213638113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914735991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2856363150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3232711486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3206580413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2138822845"/>
                    </a:ext>
                  </a:extLst>
                </a:gridCol>
                <a:gridCol w="657935">
                  <a:extLst>
                    <a:ext uri="{9D8B030D-6E8A-4147-A177-3AD203B41FA5}">
                      <a16:colId xmlns:a16="http://schemas.microsoft.com/office/drawing/2014/main" val="1518123001"/>
                    </a:ext>
                  </a:extLst>
                </a:gridCol>
              </a:tblGrid>
              <a:tr h="172801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uminol-h2o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2376693626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W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/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/10 m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ul/10m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/100m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85754314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olution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umin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m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77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5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35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428029941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iSodiumCarbonat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38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52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552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710004252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620400546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olution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2O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0.3g/m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2666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226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2.666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u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2666683904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555654541"/>
                  </a:ext>
                </a:extLst>
              </a:tr>
              <a:tr h="324684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olution when 1 and 2 is mixed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umin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arbonat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2O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2546616145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(Luminol is about 50 times in surplus compared to 18 </a:t>
                      </a:r>
                      <a:r>
                        <a:rPr lang="en-GB" sz="1000" u="none" strike="noStrike" dirty="0" err="1">
                          <a:effectLst/>
                        </a:rPr>
                        <a:t>uM</a:t>
                      </a:r>
                      <a:r>
                        <a:rPr lang="en-GB" sz="1000" u="none" strike="noStrike" dirty="0">
                          <a:effectLst/>
                        </a:rPr>
                        <a:t> in article ref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2080500474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1507147112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est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Check everything works with NONOat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820021857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1676188281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add 25 ul of Solution 1 and 2 respectively to the inner tub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1265123579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add a few ul alkaline nonoate solution to phosphate solution pH6 to start NO development in outer tub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4026875743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lose li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1858453272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ont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es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Blank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671033513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Check light formation in Photon camer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oNOat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oH2O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618831111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976116141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974374082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est 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Do as in test 1 but for scintillato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1192506285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412401064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11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Set up everything for chemiluminescence  counting and Test with test in position 1 and control in position 2 and blank in position 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4236202503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4005313668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Make tubes in opposit order. Load scintillator and start it as fast as possible.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1378268230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1516713044"/>
                  </a:ext>
                </a:extLst>
              </a:tr>
              <a:tr h="32468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Count 1 minute per sample and cycle rerun 10 tim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738484564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52014776"/>
                  </a:ext>
                </a:extLst>
              </a:tr>
              <a:tr h="1728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gridSpan="12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Lower hv settings to try to get as good signal-noise ratio as possible in the first hand between test and blank and second hand between control and test.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13" marR="3113" marT="3113" marB="0" anchor="b"/>
                </a:tc>
                <a:extLst>
                  <a:ext uri="{0D108BD9-81ED-4DB2-BD59-A6C34878D82A}">
                    <a16:rowId xmlns:a16="http://schemas.microsoft.com/office/drawing/2014/main" val="36645371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832420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3D90A34-8B53-F6FB-070E-BC0596EA9A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4790"/>
            <a:ext cx="12192000" cy="344841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DE1329B-A1D3-702A-BF28-0DAD9F6E3F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8403" y="5200381"/>
            <a:ext cx="6134100" cy="99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0047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1</TotalTime>
  <Words>619</Words>
  <Application>Microsoft Office PowerPoint</Application>
  <PresentationFormat>Widescreen</PresentationFormat>
  <Paragraphs>9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Olsson</dc:creator>
  <cp:lastModifiedBy>Stefan Olsson</cp:lastModifiedBy>
  <cp:revision>23</cp:revision>
  <dcterms:created xsi:type="dcterms:W3CDTF">2021-06-05T06:48:12Z</dcterms:created>
  <dcterms:modified xsi:type="dcterms:W3CDTF">2022-08-24T07:19:46Z</dcterms:modified>
</cp:coreProperties>
</file>